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pptx" ContentType="application/vnd.openxmlformats-officedocument.presentationml.presentation"/>
  <Override PartName="/ppt/embeddings/oleObject2.bin" ContentType="application/vnd.openxmlformats-officedocument.oleObject"/>
  <Override PartName="/ppt/media/image1.png" ContentType="image/png"/>
  <Override PartName="/ppt/media/image2.wmf" ContentType="image/x-wmf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F0B1B-A6BE-4B60-A923-F649530FD9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9DA2F-1EC8-4763-9A6E-5FE0AD10D6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556C5-A7D0-4EF2-8917-8AFEE973D2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F0DC5-2AA8-438F-8125-7A269E0102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7C95B-7768-47E5-8E4F-94407EFD1F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10486-C25E-4C1B-8CB6-215E562628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0CB16-E287-433E-9430-8F35529B27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24EF1-4BAC-4352-B5BF-36AF2FB498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D9CC2-A9F3-48C0-A8CE-D1C58ED664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81795-7240-4925-B31C-BEE4757E40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C8F7A-6DD4-4411-A03D-592C78F8E0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CC344-EACA-43B4-B0EB-C350ED2934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cc0000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cc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DA8104-9317-4F1E-AB53-AC2B22A6B557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pptx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352600" y="3552840"/>
          <a:ext cx="4505400" cy="2743200"/>
        </p:xfrm>
        <a:graphic>
          <a:graphicData uri="http://schemas.openxmlformats.org/presentationml/2006/ole">
            <p:oleObj progId="PowerPoint.Show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52600" y="3552840"/>
                    <a:ext cx="4505400" cy="2743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2395440" y="828720"/>
          <a:ext cx="4389480" cy="2408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95440" y="828720"/>
                    <a:ext cx="4389480" cy="2408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2571840" y="1047600"/>
            <a:ext cx="628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p=0.0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990960" y="1047600"/>
            <a:ext cx="628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p=0.0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428920" y="2733840"/>
            <a:ext cx="809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Global quality of lif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162240" y="2733840"/>
            <a:ext cx="82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Physical function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857760" y="2733840"/>
            <a:ext cx="82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Role function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524480" y="2733840"/>
            <a:ext cx="82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Emotional function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238720" y="2724120"/>
            <a:ext cx="82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Cognitive function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972040" y="2733840"/>
            <a:ext cx="82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Social function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433600" y="5353200"/>
            <a:ext cx="552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Pa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847960" y="5353200"/>
            <a:ext cx="676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Loss of appetit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371760" y="5362560"/>
            <a:ext cx="60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Consti-patio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790800" y="536256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Financial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4748040" y="5353200"/>
            <a:ext cx="685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Nausea vomiting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5210280" y="5353200"/>
            <a:ext cx="685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Sleeping disturbanc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848040" y="3762360"/>
            <a:ext cx="628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p&lt;0.00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262400" y="536256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Fatigu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710320" y="5372280"/>
            <a:ext cx="619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Diarrhea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6172200" y="5372280"/>
            <a:ext cx="63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</a:rPr>
              <a:t>Dyspnoea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171880" y="102888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2171880" y="146700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228760" y="192420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124000" y="238140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-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124000" y="282888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-2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171880" y="383868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171880" y="424800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228760" y="4676760"/>
            <a:ext cx="31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124000" y="507672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-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124000" y="548640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-2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571560" y="6227640"/>
            <a:ext cx="88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3-weekly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5248440" y="622764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Weekly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3238560" y="6229440"/>
            <a:ext cx="304920" cy="3045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905360" y="6229440"/>
            <a:ext cx="304920" cy="30456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6924600" y="6229440"/>
            <a:ext cx="189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962000" y="676440"/>
            <a:ext cx="80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ette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1962000" y="3184560"/>
            <a:ext cx="80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Wor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1962000" y="3508200"/>
            <a:ext cx="80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Wor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1962000" y="5867280"/>
            <a:ext cx="80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ette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57040" y="781200"/>
            <a:ext cx="52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209520" y="356220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 rot="16206000">
            <a:off x="1010160" y="1818000"/>
            <a:ext cx="19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ean change from baselin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rot="16206000">
            <a:off x="1000800" y="4570560"/>
            <a:ext cx="196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ean change from baselin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Istituto Nazionale per lo Studio e la Cura Tumori</cp:lastModifiedBy>
  <dcterms:modified xsi:type="dcterms:W3CDTF">2010-11-29T14:22:06Z</dcterms:modified>
  <cp:revision>43</cp:revision>
  <dc:subject/>
  <dc:title>PowerPoint Presentation</dc:title>
</cp:coreProperties>
</file>